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651EE-2667-48BE-9617-AB94D240D9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FEB02-DE35-4155-921B-DB9D7124EB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E27B9-955B-4813-BCDE-0DF9C6D507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A0C03-4040-47AC-B4A9-97FC022D86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87D59-462E-4305-8A36-103D178299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649A1-9AB9-4221-8D2B-8EAD60E1B7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057FB-3320-413A-94AB-D8DA1BD851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5163E-7CDE-4FBC-95EE-F10D79D078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B10AD-98AB-40E6-9F13-7FB910C06F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6790F-A188-4BA6-A320-6651D70ACB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8FE33-50C4-412D-A8B9-006737863F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B0EBB-8357-432D-AB35-F767ABB19E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3F1F34-A2E6-4F48-9819-68CD27F2C8F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000" spc="-1" strike="noStrike">
                <a:solidFill>
                  <a:srgbClr val="000000"/>
                </a:solidFill>
                <a:latin typeface="Arial"/>
              </a:rPr>
              <a:t>Supplemental Figure S2. Extended dosing with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DAC further reduces KG-1a cell viability.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KG-1a cell viability was assessed at 2, 3, 4, 5 and 6 days, with daily DAC addition, using the CellTiter-Glo assay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585720" y="1720800"/>
          <a:ext cx="7589880" cy="4222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85720" y="1720800"/>
                    <a:ext cx="7589880" cy="4222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8T19:15:16Z</dcterms:created>
  <dc:creator>Celgene</dc:creator>
  <dc:description/>
  <dc:language>en-US</dc:language>
  <cp:lastModifiedBy>Kyle MacBeth</cp:lastModifiedBy>
  <dcterms:modified xsi:type="dcterms:W3CDTF">2010-01-06T18:39:53Z</dcterms:modified>
  <cp:revision>8</cp:revision>
  <dc:subject/>
  <dc:title>Slide 1</dc:title>
</cp:coreProperties>
</file>